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69" r:id="rId3"/>
    <p:sldId id="270" r:id="rId4"/>
    <p:sldId id="271" r:id="rId5"/>
    <p:sldId id="272" r:id="rId6"/>
    <p:sldId id="273" r:id="rId7"/>
    <p:sldId id="274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8" autoAdjust="0"/>
    <p:restoredTop sz="94660"/>
  </p:normalViewPr>
  <p:slideViewPr>
    <p:cSldViewPr snapToGrid="0">
      <p:cViewPr varScale="1">
        <p:scale>
          <a:sx n="57" d="100"/>
          <a:sy n="57" d="100"/>
        </p:scale>
        <p:origin x="78" y="1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E7649B-6A5A-4970-9D65-A45E7928ADD9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FDF205-D6B8-4A23-AEF4-334E4B2F95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5462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g10cc87b9316_0_18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7" name="Google Shape;127;g10cc87b9316_0_18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g10cc87b9316_0_18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3" name="Google Shape;133;g10cc87b9316_0_18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Google Shape;138;g10cc87b9316_0_19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9" name="Google Shape;139;g10cc87b9316_0_19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g10cc87b9316_0_19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5" name="Google Shape;145;g10cc87b9316_0_19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Google Shape;150;g10cc87b9316_0_20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51" name="Google Shape;151;g10cc87b9316_0_20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Google Shape;156;g10cc87b9316_0_20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57" name="Google Shape;157;g10cc87b9316_0_20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28DB5-8572-4619-87E8-2E3B0C0B22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D22538-C93D-406E-B211-41E339C053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565755-42A8-4EF3-8321-E17C9E309B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1B5293-86B8-4205-AFD9-3A6731BC7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AA83FF-F29B-4588-84FE-01B0DE578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130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69119-DE48-472A-B907-F37186E9BA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F65C35-5AD4-41CB-AFD2-0FB72D16D6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25D8F2-6DBA-435B-B1A9-5EE3BCF8A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DECEF9-57A4-40B8-B95D-1FB7FF591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3F2B92-3860-488C-9E91-513D5CD994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180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E67DE8-B1C0-4037-BD50-8C8EF5B314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C55B87-E553-411F-8F86-03ECF6605F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6DC15F-A896-4637-8B9C-DE56171439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790B64-B924-4232-9393-C9E5D2BB4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C00EB7-206F-4917-AE71-46F993884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36483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609585" lvl="0" indent="-457189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1219170" lvl="1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828754" lvl="2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2438339" lvl="3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3047924" lvl="4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3657509" lvl="5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4267093" lvl="6" indent="-423323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4876678" lvl="7" indent="-423323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5486263" lvl="8" indent="-423323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062819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5DA90-4C98-40A9-B528-DB3EC2237D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B2BA9E-84F9-4D07-B00C-C273655328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30CE3B-DB75-488A-97F7-F7E4267B5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1E7E5D-B88C-4773-98E3-9CF2310CD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04E761-4B21-415C-9ECD-7913F9492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830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643CCD-C80F-483E-A947-087DCD0DF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7C499B-B257-4B04-B3FE-ABD9810254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C8CC3B-4822-4BA5-AC42-53DE91764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406FE9-4860-489A-AE10-3F5ABA21A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31DF2B-6CF7-47ED-9515-741EC5245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428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C5DD50-F9EA-4353-9D67-BABFC27599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37AD57-6043-4C90-AFC7-1A33905F5E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F880A6-EAEC-4767-8804-377000EF5C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3597CA-4B70-417A-A2F9-3C4B51EF9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5062F7-E873-4511-BB6C-7B4F1BD8F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6D179D-176B-4E18-8FA2-AB755C837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311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0C155F-1DC4-41CF-88ED-CECAA9AD8F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538C63-FFE6-4C77-A698-01C71D5EA0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874F72-D242-4898-8213-4F23D37EC1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CD42C5-6B3F-443E-9D80-BF7D931BFD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E7C7F5-64DE-46BE-A238-36057EBCE6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A5F86F-DFE4-460B-8BEC-D7A7132A5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E33662-F5A2-4D5F-B714-9CFB192A8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542677-A98D-45AD-9DD9-D8CE2C94CB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520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6CA624-95A3-4E03-9B5A-8506AC15A9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3D89A5-13C1-4997-963D-FC0D2D15D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671C39-07D8-469D-A34B-8112CF7981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E45EBD-81E9-4AF8-B125-29270C547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020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575E18-BCB1-4AB0-BC92-622D62B20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D1A238-9A87-4C56-99B2-0D65EC495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2794C0-19DF-4750-893B-8C5BFBFB5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145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EA55A-BD3E-4E6C-8A27-7C37DEB6BA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2871FA-A00E-4468-A886-3DD1A869F7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6A2CDB-4E64-4AA9-B7E1-5043B4B76E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09C070-D8E4-4E3A-8A76-F055D8235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828A9B-B174-4C20-A162-87A5967EB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3441C3-CBC1-4A11-BF66-1E09FFF5E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786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60A4A0-745C-4D98-9069-D98A9AC526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90E022-1647-4BFB-BA12-EB82F8BE8C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81C206-06CF-4E9D-B7E1-741F76415B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EBB126-9CE8-4E7A-87FF-47A7D569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872C1F-3100-468E-BCD2-DFBF8F960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48FB0E-795E-4EB5-8547-6D9862FEA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227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6D97E8-5C43-4EFD-983A-624D777AEF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9FBB16-3393-454B-B85D-A40804AC17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48CA70-BD50-456C-A34E-318460435C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1C7D5-DBD0-4516-ACE2-2FEDEA579F4F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3453CB-CF32-4473-B7C2-FCA8B95F99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1E4050-CAC0-4E86-8334-9E78F09BA9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50E79-452B-45BB-B473-FD19A4BC7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172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8B91C0-2AF5-470D-8AA4-6780298C3B9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Debriefing Material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D2DC0A-DB8B-42B0-9ED8-D80EB500CBF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4328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p26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 fontScale="90000"/>
          </a:bodyPr>
          <a:lstStyle/>
          <a:p>
            <a:r>
              <a:rPr lang="en"/>
              <a:t>Peripartum Cardiomyopathy</a:t>
            </a:r>
            <a:endParaRPr/>
          </a:p>
          <a:p>
            <a:endParaRPr/>
          </a:p>
        </p:txBody>
      </p:sp>
      <p:sp>
        <p:nvSpPr>
          <p:cNvPr id="130" name="Google Shape;130;p26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9844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/>
          </a:bodyPr>
          <a:lstStyle/>
          <a:p>
            <a:pPr marL="0" indent="0">
              <a:lnSpc>
                <a:spcPct val="200000"/>
              </a:lnSpc>
              <a:buNone/>
            </a:pPr>
            <a:r>
              <a:rPr lang="en" sz="2133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finition: </a:t>
            </a:r>
            <a:r>
              <a:rPr lang="en" sz="213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diopathic cardiomyopathy with new diagnosis of heart failure due to left ventricular (LV) systolic dysfunction during the last month of pregnancy or up to 5 months postpartum</a:t>
            </a:r>
            <a:endParaRPr sz="2133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40256">
              <a:lnSpc>
                <a:spcPct val="200000"/>
              </a:lnSpc>
              <a:buClr>
                <a:schemeClr val="dk1"/>
              </a:buClr>
              <a:buSzPts val="1600"/>
              <a:buFont typeface="Calibri"/>
              <a:buChar char="●"/>
            </a:pPr>
            <a:r>
              <a:rPr lang="en" sz="213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agnosis of exclusion</a:t>
            </a:r>
            <a:endParaRPr sz="2133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40256">
              <a:lnSpc>
                <a:spcPct val="200000"/>
              </a:lnSpc>
              <a:buClr>
                <a:schemeClr val="dk1"/>
              </a:buClr>
              <a:buSzPts val="1600"/>
              <a:buFont typeface="Calibri"/>
              <a:buChar char="●"/>
            </a:pPr>
            <a:r>
              <a:rPr lang="en" sz="213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 LV may not be dilated, but the ejection fraction is almost always reduced (&lt;45%)</a:t>
            </a:r>
            <a:endParaRPr sz="2133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indent="0">
              <a:lnSpc>
                <a:spcPct val="200000"/>
              </a:lnSpc>
              <a:buNone/>
            </a:pPr>
            <a:r>
              <a:rPr lang="en" sz="2133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linical Features:</a:t>
            </a:r>
            <a:endParaRPr sz="2133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40256">
              <a:lnSpc>
                <a:spcPct val="200000"/>
              </a:lnSpc>
              <a:buClr>
                <a:schemeClr val="dk1"/>
              </a:buClr>
              <a:buSzPts val="1600"/>
              <a:buFont typeface="Calibri"/>
              <a:buChar char="●"/>
            </a:pPr>
            <a:r>
              <a:rPr lang="en" sz="213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ypical heart failure symptoms: dyspnea, peripheral edema, orthopnea, etc.</a:t>
            </a:r>
            <a:endParaRPr sz="2133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40256">
              <a:lnSpc>
                <a:spcPct val="200000"/>
              </a:lnSpc>
              <a:buClr>
                <a:schemeClr val="dk1"/>
              </a:buClr>
              <a:buSzPts val="1600"/>
              <a:buFont typeface="Calibri"/>
              <a:buChar char="●"/>
            </a:pPr>
            <a:r>
              <a:rPr lang="en" sz="213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are: cardiogenic shock, arrhythmias</a:t>
            </a:r>
            <a:endParaRPr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27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 fontScale="90000"/>
          </a:bodyPr>
          <a:lstStyle/>
          <a:p>
            <a:r>
              <a:rPr lang="en"/>
              <a:t>PPCM</a:t>
            </a:r>
            <a:endParaRPr/>
          </a:p>
        </p:txBody>
      </p:sp>
      <p:sp>
        <p:nvSpPr>
          <p:cNvPr id="136" name="Google Shape;136;p27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Autofit/>
          </a:bodyPr>
          <a:lstStyle/>
          <a:p>
            <a:pPr marL="0" indent="0">
              <a:lnSpc>
                <a:spcPct val="200000"/>
              </a:lnSpc>
              <a:buClr>
                <a:schemeClr val="dk1"/>
              </a:buClr>
              <a:buSzPts val="1100"/>
              <a:buNone/>
            </a:pPr>
            <a:r>
              <a:rPr lang="en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athophysiology: 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finitive pathophysiology is uncertain, likely multifactorial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etic predisposition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urrent theory suggests timing suggests that hormonal changes (prolactin, tyrosine kinase) optimized at late pregnancy or early postpartum causes vascular insults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indent="0">
              <a:lnSpc>
                <a:spcPct val="200000"/>
              </a:lnSpc>
              <a:buClr>
                <a:schemeClr val="dk1"/>
              </a:buClr>
              <a:buSzPts val="1100"/>
              <a:buNone/>
            </a:pPr>
            <a:r>
              <a:rPr lang="en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isk Factors:</a:t>
            </a: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woman 30+ years old, black woman, preeclampsia or hypertension, multiparous, malnourishment, smoking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hared risk factors with preeclampsia/eclampsia</a:t>
            </a:r>
            <a:endParaRPr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p28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 fontScale="90000"/>
          </a:bodyPr>
          <a:lstStyle/>
          <a:p>
            <a:r>
              <a:rPr lang="en"/>
              <a:t>Treatment</a:t>
            </a:r>
            <a:endParaRPr/>
          </a:p>
        </p:txBody>
      </p:sp>
      <p:sp>
        <p:nvSpPr>
          <p:cNvPr id="142" name="Google Shape;142;p28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Autofit/>
          </a:bodyPr>
          <a:lstStyle/>
          <a:p>
            <a:pPr marL="0" indent="0">
              <a:lnSpc>
                <a:spcPct val="200000"/>
              </a:lnSpc>
              <a:buClr>
                <a:schemeClr val="dk1"/>
              </a:buClr>
              <a:buSzPts val="1100"/>
              <a:buNone/>
            </a:pPr>
            <a:r>
              <a:rPr lang="en" sz="20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irway &amp; Breathing</a:t>
            </a:r>
            <a:endParaRPr sz="20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ninvasive positive pressure ventilation – increase preload and afterload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ntubation – pregnant patients have higher risk for becoming hypoxic during rapid sequence intubation apnea due to low functional residual capacity and increased basal oxygen metabolic rate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indent="0">
              <a:lnSpc>
                <a:spcPct val="200000"/>
              </a:lnSpc>
              <a:buNone/>
            </a:pPr>
            <a:r>
              <a:rPr lang="en" sz="20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irculation</a:t>
            </a:r>
            <a:endParaRPr sz="20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crease preload – loop diuretics and nitrates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crease afterload – hydralazine or nitrates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intain cardiac output – vasopressors or inotropes; no consensus on best agent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29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 fontScale="90000"/>
          </a:bodyPr>
          <a:lstStyle/>
          <a:p>
            <a:r>
              <a:rPr lang="en"/>
              <a:t>Treatment</a:t>
            </a:r>
            <a:endParaRPr/>
          </a:p>
        </p:txBody>
      </p:sp>
      <p:sp>
        <p:nvSpPr>
          <p:cNvPr id="148" name="Google Shape;148;p29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/>
          </a:bodyPr>
          <a:lstStyle/>
          <a:p>
            <a:pPr marL="0" indent="0">
              <a:lnSpc>
                <a:spcPct val="200000"/>
              </a:lnSpc>
              <a:buClr>
                <a:schemeClr val="dk1"/>
              </a:buClr>
              <a:buSzPts val="1100"/>
              <a:buNone/>
            </a:pPr>
            <a:r>
              <a:rPr lang="en" sz="20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romboembolic prophylaxis</a:t>
            </a:r>
            <a:endParaRPr sz="2000" u="sng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ypercoagulable state intrinsically in peripartum period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ticoagulation indicated when ejection fraction &lt;30% and within 2-3 months following delivery (Arany &amp; Elkayam, 2016)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eparin and low molecular weight heparin are okay for use during pregnancy or breastfeeding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arfarin and direct-acting oral anticoagulants (DOACs) should not be used during pregnancy for possible harm to fetus</a:t>
            </a:r>
            <a:endParaRPr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Google Shape;153;p30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 fontScale="90000"/>
          </a:bodyPr>
          <a:lstStyle/>
          <a:p>
            <a:r>
              <a:rPr lang="en"/>
              <a:t>Prepartum considerations</a:t>
            </a:r>
            <a:endParaRPr/>
          </a:p>
        </p:txBody>
      </p:sp>
      <p:sp>
        <p:nvSpPr>
          <p:cNvPr id="154" name="Google Shape;154;p30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/>
          </a:bodyPr>
          <a:lstStyle/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arly continuous fetal heart monitoring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creasing volume status can compromise uterine perfusion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void phenylephrine and norepinephrine which cause vasoconstriction of the uterine arteries which can cause placental insufficiency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arfarin and DOACs should not be given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CE inhibitors or ARBs should not be given to pregnant patients for possible injury to fetus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indent="0">
              <a:spcAft>
                <a:spcPts val="1600"/>
              </a:spcAft>
              <a:buNone/>
            </a:pPr>
            <a:endParaRPr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Google Shape;159;p31"/>
          <p:cNvSpPr txBox="1">
            <a:spLocks noGrp="1"/>
          </p:cNvSpPr>
          <p:nvPr>
            <p:ph type="title"/>
          </p:nvPr>
        </p:nvSpPr>
        <p:spPr>
          <a:xfrm>
            <a:off x="415600" y="593367"/>
            <a:ext cx="11360800" cy="7636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 fontScale="90000"/>
          </a:bodyPr>
          <a:lstStyle/>
          <a:p>
            <a:r>
              <a:rPr lang="en"/>
              <a:t>Consultant Considerations</a:t>
            </a:r>
            <a:endParaRPr/>
          </a:p>
        </p:txBody>
      </p:sp>
      <p:sp>
        <p:nvSpPr>
          <p:cNvPr id="160" name="Google Shape;160;p31"/>
          <p:cNvSpPr txBox="1">
            <a:spLocks noGrp="1"/>
          </p:cNvSpPr>
          <p:nvPr>
            <p:ph type="body" idx="1"/>
          </p:nvPr>
        </p:nvSpPr>
        <p:spPr>
          <a:xfrm>
            <a:off x="415600" y="1536633"/>
            <a:ext cx="11360800" cy="45552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rmAutofit/>
          </a:bodyPr>
          <a:lstStyle/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bstetrics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lvl="1"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o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mergency cesarean section delivery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lvl="1"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o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etal heart rate monitoring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●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ardiology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lvl="1"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o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nagement of cardiogenic shock</a:t>
            </a:r>
            <a:endParaRPr sz="2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lvl="1" indent="-431789">
              <a:lnSpc>
                <a:spcPct val="200000"/>
              </a:lnSpc>
              <a:buClr>
                <a:schemeClr val="dk1"/>
              </a:buClr>
              <a:buSzPts val="1500"/>
              <a:buFont typeface="Calibri"/>
              <a:buChar char="o"/>
            </a:pPr>
            <a:r>
              <a:rPr lang="en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ardiac assist devices (e.g. LV assist device, extracorporeal membrane oxygenation (ECMO), intra-aortic balloon pump, cardiac defibrillator)</a:t>
            </a:r>
            <a:endParaRPr sz="2267"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7</Words>
  <Application>Microsoft Office PowerPoint</Application>
  <PresentationFormat>Widescreen</PresentationFormat>
  <Paragraphs>42</Paragraphs>
  <Slides>7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Debriefing Materials</vt:lpstr>
      <vt:lpstr>Peripartum Cardiomyopathy </vt:lpstr>
      <vt:lpstr>PPCM</vt:lpstr>
      <vt:lpstr>Treatment</vt:lpstr>
      <vt:lpstr>Treatment</vt:lpstr>
      <vt:lpstr>Prepartum considerations</vt:lpstr>
      <vt:lpstr>Consultant Considera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briefing Materials</dc:title>
  <dc:creator>Kosoko, Adeola A</dc:creator>
  <cp:lastModifiedBy>Kosoko, Adeola A</cp:lastModifiedBy>
  <cp:revision>1</cp:revision>
  <dcterms:created xsi:type="dcterms:W3CDTF">2022-04-06T21:17:35Z</dcterms:created>
  <dcterms:modified xsi:type="dcterms:W3CDTF">2022-04-06T21:18:34Z</dcterms:modified>
</cp:coreProperties>
</file>